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16C5DF-DBEA-48DE-B09E-ABAAD3AC70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D5DEAA-9648-4F03-A4EB-339F2B52C9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C3613D-26A7-4C66-930C-A58A52CFDE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5163FF-EE38-4B35-8575-3C1A8DEE18A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273A9C-7123-4BDF-A91B-9DF7C4C326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391FA-79CF-45FF-9DAE-12BD9EBDFC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E60F98-2767-4B94-BD32-2C6A28C254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1F1FF3-58D5-4D50-848F-42A275B253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F4FE2B-F168-43ED-81A8-A2A4FCB7F6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53FA19-54E6-4E78-BC23-0A91A0B9D0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384CFC-E998-4A9C-AF36-B7EED82D22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94BE3C-0532-46C0-8CE5-459EE046F4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ABF7D50-E23B-4E31-AB48-00A499D94FE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623600" y="157320"/>
            <a:ext cx="221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oxorubicin treated HEK293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 rot="16200000">
            <a:off x="-32040" y="1067760"/>
            <a:ext cx="79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ells (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371520" y="369720"/>
          <a:ext cx="4676760" cy="17431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71520" y="369720"/>
                    <a:ext cx="4676760" cy="1743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"/>
          <p:cNvSpPr/>
          <p:nvPr/>
        </p:nvSpPr>
        <p:spPr>
          <a:xfrm>
            <a:off x="290520" y="233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"/>
          <p:cNvGrpSpPr/>
          <p:nvPr/>
        </p:nvGrpSpPr>
        <p:grpSpPr>
          <a:xfrm>
            <a:off x="1447920" y="844560"/>
            <a:ext cx="1104840" cy="152280"/>
            <a:chOff x="1447920" y="844560"/>
            <a:chExt cx="1104840" cy="152280"/>
          </a:xfrm>
        </p:grpSpPr>
        <p:sp>
          <p:nvSpPr>
            <p:cNvPr id="47" name=""/>
            <p:cNvSpPr/>
            <p:nvPr/>
          </p:nvSpPr>
          <p:spPr>
            <a:xfrm>
              <a:off x="1447920" y="844560"/>
              <a:ext cx="1104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552760" y="844560"/>
              <a:ext cx="0" cy="152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9" name=""/>
          <p:cNvSpPr/>
          <p:nvPr/>
        </p:nvSpPr>
        <p:spPr>
          <a:xfrm>
            <a:off x="1742760" y="736560"/>
            <a:ext cx="55116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&lt;0.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"/>
          <p:cNvGrpSpPr/>
          <p:nvPr/>
        </p:nvGrpSpPr>
        <p:grpSpPr>
          <a:xfrm>
            <a:off x="2590920" y="844560"/>
            <a:ext cx="2100960" cy="152280"/>
            <a:chOff x="2590920" y="844560"/>
            <a:chExt cx="2100960" cy="152280"/>
          </a:xfrm>
        </p:grpSpPr>
        <p:grpSp>
          <p:nvGrpSpPr>
            <p:cNvPr id="51" name=""/>
            <p:cNvGrpSpPr/>
            <p:nvPr/>
          </p:nvGrpSpPr>
          <p:grpSpPr>
            <a:xfrm>
              <a:off x="2590920" y="844560"/>
              <a:ext cx="2100960" cy="152280"/>
              <a:chOff x="2590920" y="844560"/>
              <a:chExt cx="2100960" cy="152280"/>
            </a:xfrm>
          </p:grpSpPr>
          <p:sp>
            <p:nvSpPr>
              <p:cNvPr id="52" name=""/>
              <p:cNvSpPr/>
              <p:nvPr/>
            </p:nvSpPr>
            <p:spPr>
              <a:xfrm>
                <a:off x="2590920" y="844560"/>
                <a:ext cx="2100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4691880" y="84456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4" name=""/>
            <p:cNvSpPr/>
            <p:nvPr/>
          </p:nvSpPr>
          <p:spPr>
            <a:xfrm>
              <a:off x="2590920" y="844560"/>
              <a:ext cx="0" cy="152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"/>
          <p:cNvSpPr/>
          <p:nvPr/>
        </p:nvSpPr>
        <p:spPr>
          <a:xfrm>
            <a:off x="3273120" y="738360"/>
            <a:ext cx="55116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=0.0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32640" y="380988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4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11120" y="292572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092600" y="2362320"/>
            <a:ext cx="57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oc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250360" y="2362320"/>
            <a:ext cx="75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ANK-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481560" y="2362320"/>
            <a:ext cx="83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wt RAN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198440" y="2386080"/>
            <a:ext cx="29894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179440" y="2157480"/>
            <a:ext cx="85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EK293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90240" y="21877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" descr=""/>
          <p:cNvPicPr/>
          <p:nvPr/>
        </p:nvPicPr>
        <p:blipFill>
          <a:blip r:embed="rId3"/>
          <a:stretch/>
        </p:blipFill>
        <p:spPr>
          <a:xfrm>
            <a:off x="712800" y="2614680"/>
            <a:ext cx="3773520" cy="1785960"/>
          </a:xfrm>
          <a:prstGeom prst="rect">
            <a:avLst/>
          </a:prstGeom>
          <a:ln w="0">
            <a:noFill/>
          </a:ln>
        </p:spPr>
      </p:pic>
      <p:sp>
        <p:nvSpPr>
          <p:cNvPr id="65" name=""/>
          <p:cNvSpPr/>
          <p:nvPr/>
        </p:nvSpPr>
        <p:spPr>
          <a:xfrm>
            <a:off x="545400" y="621036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4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23880" y="532620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897280" y="4773600"/>
            <a:ext cx="71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ANK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068120" y="4762440"/>
            <a:ext cx="1494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wt RANK+RANK-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276200" y="4772160"/>
            <a:ext cx="25322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975320" y="4543560"/>
            <a:ext cx="111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DA-MB-23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01400" y="4491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" descr=""/>
          <p:cNvPicPr/>
          <p:nvPr/>
        </p:nvPicPr>
        <p:blipFill>
          <a:blip r:embed="rId4"/>
          <a:stretch/>
        </p:blipFill>
        <p:spPr>
          <a:xfrm>
            <a:off x="1257480" y="4986360"/>
            <a:ext cx="2535120" cy="1785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24T16:18:07Z</dcterms:created>
  <dc:creator>tasos p</dc:creator>
  <dc:description/>
  <dc:language>en-US</dc:language>
  <cp:lastModifiedBy>tasos p</cp:lastModifiedBy>
  <dcterms:modified xsi:type="dcterms:W3CDTF">2012-06-06T15:13:41Z</dcterms:modified>
  <cp:revision>4</cp:revision>
  <dc:subject/>
  <dc:title>Διαφάνεια 1</dc:title>
</cp:coreProperties>
</file>